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6" d="100"/>
          <a:sy n="56" d="100"/>
        </p:scale>
        <p:origin x="-1502" y="37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477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8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0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396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460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800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133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777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524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516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190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AAD837-360F-46F2-8775-3CF535BF72DD}" type="datetimeFigureOut">
              <a:rPr lang="en-US" smtClean="0"/>
              <a:t>3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1EA5A-2D19-43E2-B171-C930EEC72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947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9643839"/>
              </p:ext>
            </p:extLst>
          </p:nvPr>
        </p:nvGraphicFramePr>
        <p:xfrm>
          <a:off x="1270000" y="1475656"/>
          <a:ext cx="4224338" cy="284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Prism 6" r:id="rId3" imgW="4224064" imgH="2845137" progId="Prism6.Document">
                  <p:embed/>
                </p:oleObj>
              </mc:Choice>
              <mc:Fallback>
                <p:oleObj name="Prism 6" r:id="rId3" imgW="4224064" imgH="284513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0000" y="1475656"/>
                        <a:ext cx="4224338" cy="284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52736" y="4500215"/>
            <a:ext cx="511256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upplemental Figure S1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MMP-9 activity comparison between protein G plates and non-coated plates.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This experiment was conducted exactly as described in Materials and Methods with the only exception being the way the mouse anti-MMP-9 antibody was immobilized to the plat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Protein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G coated plates were obtained from Thermo Fisher Scientific, and the anti-MMP-9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antibody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(Cat No. MS-817-P, Thermo Fisher Scientific)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was immobilized to these plates by incubating at room temperature for 2 h in a microplate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mixer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see Materials and Methods). In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the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plates that were not pre-coated with protein G, the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anti-MMP-9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antibody was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mmobilized by passive absorption to </a:t>
            </a:r>
            <a:r>
              <a:rPr lang="en-US" sz="1100" dirty="0" err="1">
                <a:latin typeface="Arial" pitchFamily="34" charset="0"/>
                <a:cs typeface="Arial" pitchFamily="34" charset="0"/>
              </a:rPr>
              <a:t>Fluotrac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 600 high-binding plates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(Greiner Bio-One) overnight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at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4°C (1 </a:t>
            </a:r>
            <a:r>
              <a:rPr lang="en-US" sz="1100" dirty="0" smtClean="0">
                <a:latin typeface="Symbol" pitchFamily="18" charset="2"/>
                <a:cs typeface="Arial" pitchFamily="34" charset="0"/>
              </a:rPr>
              <a:t>m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g of antibody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in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100 </a:t>
            </a:r>
            <a:r>
              <a:rPr lang="en-US" sz="1100" dirty="0" smtClean="0">
                <a:latin typeface="Symbol" pitchFamily="18" charset="2"/>
                <a:cs typeface="Arial" pitchFamily="34" charset="0"/>
              </a:rPr>
              <a:t>m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l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phosphate-buffered saline, </a:t>
            </a:r>
            <a:r>
              <a:rPr lang="en-US" sz="1100" dirty="0">
                <a:latin typeface="Arial" pitchFamily="34" charset="0"/>
                <a:cs typeface="Arial" pitchFamily="34" charset="0"/>
              </a:rPr>
              <a:t>pH 7.4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. Active human recombinant MMP-9 (0.5, 5 and 10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ng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) was added to the plates and incubated overnight at 4°C. The fluorescence was measured at 24 h after adding the FRET peptide to the plates (Excitation= 485 nm; Emission=528 nm). RFUs: relative fluorescence units. **p&lt;0.01 and ***p&lt;0.001 with respect to protein G coated plates (Student’s t-test; n=3 per concentration of MMP-9)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8069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21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6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uardo Candelario-Jalil</dc:creator>
  <cp:lastModifiedBy>Eduardo</cp:lastModifiedBy>
  <cp:revision>10</cp:revision>
  <dcterms:created xsi:type="dcterms:W3CDTF">2013-03-11T14:18:52Z</dcterms:created>
  <dcterms:modified xsi:type="dcterms:W3CDTF">2013-03-12T02:23:53Z</dcterms:modified>
</cp:coreProperties>
</file>